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  <p:sldId id="265" r:id="rId3"/>
    <p:sldId id="267" r:id="rId4"/>
    <p:sldId id="268" r:id="rId5"/>
    <p:sldId id="269" r:id="rId6"/>
  </p:sldIdLst>
  <p:sldSz cx="5761038" cy="9721850"/>
  <p:notesSz cx="6858000" cy="9686925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>
        <p:scale>
          <a:sx n="66" d="100"/>
          <a:sy n="66" d="100"/>
        </p:scale>
        <p:origin x="-3180" y="-390"/>
      </p:cViewPr>
      <p:guideLst>
        <p:guide orient="horz" pos="3062"/>
        <p:guide pos="181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432078" y="3020076"/>
            <a:ext cx="4896882" cy="2083896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864157" y="5509049"/>
            <a:ext cx="4032727" cy="248447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A258C-AF0C-4162-A72B-A91F2D415DAE}" type="datetimeFigureOut">
              <a:rPr lang="it-IT" smtClean="0"/>
              <a:t>13/10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7D1C3-D19D-4BC1-A470-9A90643DC1D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722726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A258C-AF0C-4162-A72B-A91F2D415DAE}" type="datetimeFigureOut">
              <a:rPr lang="it-IT" smtClean="0"/>
              <a:t>13/10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7D1C3-D19D-4BC1-A470-9A90643DC1D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880797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2632475" y="612117"/>
            <a:ext cx="816147" cy="13065986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181033" y="612117"/>
            <a:ext cx="2355424" cy="13065986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A258C-AF0C-4162-A72B-A91F2D415DAE}" type="datetimeFigureOut">
              <a:rPr lang="it-IT" smtClean="0"/>
              <a:t>13/10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7D1C3-D19D-4BC1-A470-9A90643DC1D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752186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A258C-AF0C-4162-A72B-A91F2D415DAE}" type="datetimeFigureOut">
              <a:rPr lang="it-IT" smtClean="0"/>
              <a:t>13/10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7D1C3-D19D-4BC1-A470-9A90643DC1D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122941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5082" y="6247189"/>
            <a:ext cx="4896882" cy="1930867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5082" y="4120536"/>
            <a:ext cx="4896882" cy="212665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A258C-AF0C-4162-A72B-A91F2D415DAE}" type="datetimeFigureOut">
              <a:rPr lang="it-IT" smtClean="0"/>
              <a:t>13/10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7D1C3-D19D-4BC1-A470-9A90643DC1D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556586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181034" y="3573681"/>
            <a:ext cx="1585285" cy="1010442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1862336" y="3573681"/>
            <a:ext cx="1586286" cy="1010442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A258C-AF0C-4162-A72B-A91F2D415DAE}" type="datetimeFigureOut">
              <a:rPr lang="it-IT" smtClean="0"/>
              <a:t>13/10/20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7D1C3-D19D-4BC1-A470-9A90643DC1D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629493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288052" y="389326"/>
            <a:ext cx="5184934" cy="1620308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288053" y="2176165"/>
            <a:ext cx="2545459" cy="9069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88053" y="3083087"/>
            <a:ext cx="2545459" cy="560131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2926529" y="2176165"/>
            <a:ext cx="2546459" cy="9069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2926529" y="3083087"/>
            <a:ext cx="2546459" cy="560131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A258C-AF0C-4162-A72B-A91F2D415DAE}" type="datetimeFigureOut">
              <a:rPr lang="it-IT" smtClean="0"/>
              <a:t>13/10/2016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7D1C3-D19D-4BC1-A470-9A90643DC1D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533492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A258C-AF0C-4162-A72B-A91F2D415DAE}" type="datetimeFigureOut">
              <a:rPr lang="it-IT" smtClean="0"/>
              <a:t>13/10/2016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7D1C3-D19D-4BC1-A470-9A90643DC1D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373670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A258C-AF0C-4162-A72B-A91F2D415DAE}" type="datetimeFigureOut">
              <a:rPr lang="it-IT" smtClean="0"/>
              <a:t>13/10/2016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7D1C3-D19D-4BC1-A470-9A90643DC1D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198036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288052" y="387074"/>
            <a:ext cx="1895342" cy="164731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252406" y="387075"/>
            <a:ext cx="3220580" cy="829733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288052" y="2034388"/>
            <a:ext cx="1895342" cy="665001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A258C-AF0C-4162-A72B-A91F2D415DAE}" type="datetimeFigureOut">
              <a:rPr lang="it-IT" smtClean="0"/>
              <a:t>13/10/20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7D1C3-D19D-4BC1-A470-9A90643DC1D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253283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129205" y="6805295"/>
            <a:ext cx="3456623" cy="80340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129205" y="868666"/>
            <a:ext cx="3456623" cy="583311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129205" y="7608698"/>
            <a:ext cx="3456623" cy="114096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A258C-AF0C-4162-A72B-A91F2D415DAE}" type="datetimeFigureOut">
              <a:rPr lang="it-IT" smtClean="0"/>
              <a:t>13/10/20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7D1C3-D19D-4BC1-A470-9A90643DC1D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047123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288052" y="389326"/>
            <a:ext cx="5184934" cy="162030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288052" y="2268433"/>
            <a:ext cx="5184934" cy="641597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288052" y="9010715"/>
            <a:ext cx="1344242" cy="51759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3A258C-AF0C-4162-A72B-A91F2D415DAE}" type="datetimeFigureOut">
              <a:rPr lang="it-IT" smtClean="0"/>
              <a:t>13/10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1968356" y="9010715"/>
            <a:ext cx="1824329" cy="51759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128744" y="9010715"/>
            <a:ext cx="1344242" cy="51759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67D1C3-D19D-4BC1-A470-9A90643DC1D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788104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1908" y="397309"/>
            <a:ext cx="5518931" cy="79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7012124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107" y="397309"/>
            <a:ext cx="5518931" cy="79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204231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7611" y="396429"/>
            <a:ext cx="5518931" cy="79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197454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107" y="382477"/>
            <a:ext cx="5518931" cy="79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206588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1908" y="397309"/>
            <a:ext cx="5518931" cy="79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CasellaDiTesto 5"/>
          <p:cNvSpPr txBox="1"/>
          <p:nvPr/>
        </p:nvSpPr>
        <p:spPr>
          <a:xfrm>
            <a:off x="993" y="7395721"/>
            <a:ext cx="576064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2: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TL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or </a:t>
            </a:r>
            <a:r>
              <a:rPr lang="it-IT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usarium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ar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ot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FER), fumonisin B1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amination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FB1) and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y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o silking (DTS). Marker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ame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re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sted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n the right side of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ach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G and the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rresponding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tic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tance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in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ntiMorgan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on the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ft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ide.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TL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re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rawn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right of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ach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G and are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ed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ntral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r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cating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1-LOD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fidence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val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ternal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in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e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cating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2-LOD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fidence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val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TL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re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dentified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y the trait code,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llowed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y the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ear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2011/2012), the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wing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ime (A/B) and the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oculation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chnique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F/T) for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hich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QTL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tected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TL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or FER are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orted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ith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d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r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FB1 in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lack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DTS in green.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281782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4</TotalTime>
  <Words>131</Words>
  <Application>Microsoft Office PowerPoint</Application>
  <PresentationFormat>Personalizzato</PresentationFormat>
  <Paragraphs>1</Paragraphs>
  <Slides>5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5</vt:i4>
      </vt:variant>
    </vt:vector>
  </HeadingPairs>
  <TitlesOfParts>
    <vt:vector size="6" baseType="lpstr"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>Università Cattolica del Sacro Cuore - Piacenz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ist.maroccolab-pc</dc:creator>
  <cp:lastModifiedBy>ist.maroccolab-pc</cp:lastModifiedBy>
  <cp:revision>15</cp:revision>
  <cp:lastPrinted>2016-01-11T16:00:20Z</cp:lastPrinted>
  <dcterms:created xsi:type="dcterms:W3CDTF">2015-12-18T13:57:40Z</dcterms:created>
  <dcterms:modified xsi:type="dcterms:W3CDTF">2016-10-13T16:28:30Z</dcterms:modified>
</cp:coreProperties>
</file>